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735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451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509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70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479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934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465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74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55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954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190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A5867-34C5-4D0D-9528-BB6B6E19BA5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A2AFF-A904-4862-8FCA-81A3E8359F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994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91" y="622852"/>
            <a:ext cx="5208892" cy="3657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3378" y="622852"/>
            <a:ext cx="5074923" cy="3657600"/>
          </a:xfrm>
          <a:prstGeom prst="rect">
            <a:avLst/>
          </a:prstGeom>
        </p:spPr>
      </p:pic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913280" y="284298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6693027" y="284298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756937" y="5646486"/>
            <a:ext cx="6863669" cy="655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1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-Protein 2D interaction diagram A) Quercetin-4JPS, B) Quercetin-5JJM 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2116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035" y="978337"/>
            <a:ext cx="6591195" cy="27432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61" y="978337"/>
            <a:ext cx="3657600" cy="2743200"/>
          </a:xfrm>
          <a:prstGeom prst="rect">
            <a:avLst/>
          </a:prstGeom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542219" y="263796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8084505" y="218037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112548" y="5237054"/>
            <a:ext cx="6413590" cy="3312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r>
              <a:rPr kumimoji="0" lang="en-US" sz="14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 ligand interaction fraction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Quercetin-4JPS, B) Quercetin-5JJM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3098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2684" t="9783" r="2600"/>
          <a:stretch/>
        </p:blipFill>
        <p:spPr>
          <a:xfrm>
            <a:off x="1338467" y="1060173"/>
            <a:ext cx="3628222" cy="3657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4858" t="6075" r="2388" b="1362"/>
          <a:stretch/>
        </p:blipFill>
        <p:spPr>
          <a:xfrm>
            <a:off x="7129669" y="1060174"/>
            <a:ext cx="4244622" cy="3657600"/>
          </a:xfrm>
          <a:prstGeom prst="rect">
            <a:avLst/>
          </a:prstGeom>
        </p:spPr>
      </p:pic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522879" y="218037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7129669" y="224039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987246" y="5347423"/>
            <a:ext cx="6474807" cy="6230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-Protein interaction Time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Quercetin-4JPS, B) Quercetin-5JJM</a:t>
            </a:r>
            <a:endParaRPr lang="en-IN" sz="12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8979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957" y="1087203"/>
            <a:ext cx="4285283" cy="914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87" r="7913"/>
          <a:stretch/>
        </p:blipFill>
        <p:spPr>
          <a:xfrm>
            <a:off x="397564" y="2001603"/>
            <a:ext cx="4996071" cy="27432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1114" y="291549"/>
            <a:ext cx="2438400" cy="18288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1514" y="2001603"/>
            <a:ext cx="3657600" cy="2743200"/>
          </a:xfrm>
          <a:prstGeom prst="rect">
            <a:avLst/>
          </a:prstGeom>
        </p:spPr>
      </p:pic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448157" y="291549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8046714" y="291549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490828" y="5331228"/>
            <a:ext cx="5857888" cy="655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idue index of protein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Quercetin-4JPS, B) Quercetin-5JJM</a:t>
            </a:r>
            <a:endParaRPr lang="en-IN" sz="12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915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7270" y="1075409"/>
            <a:ext cx="4876800" cy="3657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279" y="1075409"/>
            <a:ext cx="4876800" cy="3657600"/>
          </a:xfrm>
          <a:prstGeom prst="rect">
            <a:avLst/>
          </a:prstGeom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72279" y="318056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6867270" y="318054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604164" y="5305293"/>
            <a:ext cx="5171346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 Properties A) Quercetin-4JPS, B) Quercetin-5JJM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8295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84</Words>
  <Application>Microsoft Office PowerPoint</Application>
  <PresentationFormat>Widescreen</PresentationFormat>
  <Paragraphs>1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22</cp:revision>
  <dcterms:created xsi:type="dcterms:W3CDTF">2024-03-21T08:29:25Z</dcterms:created>
  <dcterms:modified xsi:type="dcterms:W3CDTF">2024-03-27T07:08:51Z</dcterms:modified>
</cp:coreProperties>
</file>